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slides/slide1.xml" ContentType="application/vnd.openxmlformats-officedocument.presentationml.slide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charts/chart5.xml" ContentType="application/vnd.openxmlformats-officedocument.drawingml.chart+xml"/>
  <Override PartName="/ppt/charts/style4.xml" ContentType="application/vnd.ms-office.chartstyle+xml"/>
  <Override PartName="/ppt/charts/colors5.xml" ContentType="application/vnd.ms-office.chartcolorstyle+xml"/>
  <Override PartName="/ppt/charts/colors4.xml" ContentType="application/vnd.ms-office.chartcolorstyle+xml"/>
  <Override PartName="/ppt/charts/style5.xml" ContentType="application/vnd.ms-office.chartstyle+xml"/>
  <Override PartName="/ppt/charts/chart4.xml" ContentType="application/vnd.openxmlformats-officedocument.drawingml.chart+xml"/>
  <Override PartName="/ppt/charts/colors3.xml" ContentType="application/vnd.ms-office.chartcolorstyle+xml"/>
  <Override PartName="/ppt/charts/style3.xml" ContentType="application/vnd.ms-office.chartstyle+xml"/>
  <Override PartName="/ppt/charts/chart3.xml" ContentType="application/vnd.openxmlformats-officedocument.drawingml.chart+xml"/>
  <Override PartName="/ppt/charts/colors2.xml" ContentType="application/vnd.ms-office.chartcolorstyle+xml"/>
  <Override PartName="/ppt/charts/style2.xml" ContentType="application/vnd.ms-office.chartstyle+xml"/>
  <Override PartName="/ppt/charts/chart2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charts/chart1.xml" ContentType="application/vnd.openxmlformats-officedocument.drawingml.char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238"/>
  </p:normalViewPr>
  <p:slideViewPr>
    <p:cSldViewPr snapToGrid="0">
      <p:cViewPr varScale="1">
        <p:scale>
          <a:sx n="97" d="100"/>
          <a:sy n="97" d="100"/>
        </p:scale>
        <p:origin x="20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supplementary%20cell%20counts%20graph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32494\Desktop\F%20by%20F%204%20A\Figure%207\7c-d\supplementary%20cell%20counts%20graphs%20with%20other%20T%20cells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1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5CB-8742-AD4F-625F429EAE08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5CB-8742-AD4F-625F429EAE08}"/>
              </c:ext>
            </c:extLst>
          </c:dPt>
          <c:dPt>
            <c:idx val="2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5CB-8742-AD4F-625F429EAE08}"/>
              </c:ext>
            </c:extLst>
          </c:dPt>
          <c:dPt>
            <c:idx val="3"/>
            <c:bubble3D val="0"/>
            <c:spPr>
              <a:solidFill>
                <a:srgbClr val="FFA90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5CB-8742-AD4F-625F429EAE08}"/>
              </c:ext>
            </c:extLst>
          </c:dPt>
          <c:dPt>
            <c:idx val="4"/>
            <c:bubble3D val="0"/>
            <c:spPr>
              <a:solidFill>
                <a:schemeClr val="accent3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5CB-8742-AD4F-625F429EAE08}"/>
              </c:ext>
            </c:extLst>
          </c:dPt>
          <c:cat>
            <c:strRef>
              <c:f>'Main T cell types'!$G$4:$G$8</c:f>
              <c:strCache>
                <c:ptCount val="5"/>
                <c:pt idx="0">
                  <c:v>CTLs</c:v>
                </c:pt>
                <c:pt idx="1">
                  <c:v>Tregs</c:v>
                </c:pt>
                <c:pt idx="2">
                  <c:v>Th1</c:v>
                </c:pt>
                <c:pt idx="3">
                  <c:v>Th2</c:v>
                </c:pt>
                <c:pt idx="4">
                  <c:v>Other T-cells</c:v>
                </c:pt>
              </c:strCache>
            </c:strRef>
          </c:cat>
          <c:val>
            <c:numRef>
              <c:f>'Main T cell types'!$H$4:$H$8</c:f>
              <c:numCache>
                <c:formatCode>General</c:formatCode>
                <c:ptCount val="5"/>
                <c:pt idx="0">
                  <c:v>14.426263463131731</c:v>
                </c:pt>
                <c:pt idx="1">
                  <c:v>5.0538999999999996</c:v>
                </c:pt>
                <c:pt idx="2">
                  <c:v>0.63173159999999995</c:v>
                </c:pt>
                <c:pt idx="3">
                  <c:v>7.7460000000000004</c:v>
                </c:pt>
                <c:pt idx="4">
                  <c:v>4.35998342999171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95CB-8742-AD4F-625F429EAE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b="0" i="0" u="none" strike="noStrike" baseline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D11 + anti-PD-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6F4-E446-98E8-EB2F1389988D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6F4-E446-98E8-EB2F1389988D}"/>
              </c:ext>
            </c:extLst>
          </c:dPt>
          <c:dPt>
            <c:idx val="2"/>
            <c:bubble3D val="0"/>
            <c:spPr>
              <a:solidFill>
                <a:schemeClr val="accent4">
                  <a:lumMod val="40000"/>
                  <a:lumOff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6F4-E446-98E8-EB2F1389988D}"/>
              </c:ext>
            </c:extLst>
          </c:dPt>
          <c:dPt>
            <c:idx val="3"/>
            <c:bubble3D val="0"/>
            <c:spPr>
              <a:solidFill>
                <a:srgbClr val="FFA90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6F4-E446-98E8-EB2F1389988D}"/>
              </c:ext>
            </c:extLst>
          </c:dPt>
          <c:dPt>
            <c:idx val="4"/>
            <c:bubble3D val="0"/>
            <c:spPr>
              <a:solidFill>
                <a:schemeClr val="accent3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6F4-E446-98E8-EB2F1389988D}"/>
              </c:ext>
            </c:extLst>
          </c:dPt>
          <c:cat>
            <c:strRef>
              <c:f>'Main T cell types'!$G$4:$G$8</c:f>
              <c:strCache>
                <c:ptCount val="5"/>
                <c:pt idx="0">
                  <c:v>CTLs</c:v>
                </c:pt>
                <c:pt idx="1">
                  <c:v>Tregs</c:v>
                </c:pt>
                <c:pt idx="2">
                  <c:v>Th1</c:v>
                </c:pt>
                <c:pt idx="3">
                  <c:v>Th2</c:v>
                </c:pt>
                <c:pt idx="4">
                  <c:v>Other T-cells</c:v>
                </c:pt>
              </c:strCache>
            </c:strRef>
          </c:cat>
          <c:val>
            <c:numRef>
              <c:f>'Main T cell types'!$J$4:$J$8</c:f>
              <c:numCache>
                <c:formatCode>General</c:formatCode>
                <c:ptCount val="5"/>
                <c:pt idx="0">
                  <c:v>15.362697376231745</c:v>
                </c:pt>
                <c:pt idx="1">
                  <c:v>1.2346999999999999</c:v>
                </c:pt>
                <c:pt idx="2">
                  <c:v>0.94978039999999997</c:v>
                </c:pt>
                <c:pt idx="3">
                  <c:v>7.9189999999999996</c:v>
                </c:pt>
                <c:pt idx="4">
                  <c:v>4.3808619256796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6F4-E446-98E8-EB2F138998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pilimumab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869-C147-A6ED-ED6DA1A5B958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869-C147-A6ED-ED6DA1A5B958}"/>
              </c:ext>
            </c:extLst>
          </c:dPt>
          <c:dPt>
            <c:idx val="2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869-C147-A6ED-ED6DA1A5B958}"/>
              </c:ext>
            </c:extLst>
          </c:dPt>
          <c:dPt>
            <c:idx val="3"/>
            <c:bubble3D val="0"/>
            <c:spPr>
              <a:solidFill>
                <a:srgbClr val="FFA90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869-C147-A6ED-ED6DA1A5B958}"/>
              </c:ext>
            </c:extLst>
          </c:dPt>
          <c:dPt>
            <c:idx val="4"/>
            <c:bubble3D val="0"/>
            <c:spPr>
              <a:solidFill>
                <a:schemeClr val="accent3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869-C147-A6ED-ED6DA1A5B958}"/>
              </c:ext>
            </c:extLst>
          </c:dPt>
          <c:cat>
            <c:strRef>
              <c:f>'Main T cell types'!$G$4:$G$8</c:f>
              <c:strCache>
                <c:ptCount val="5"/>
                <c:pt idx="0">
                  <c:v>CTLs</c:v>
                </c:pt>
                <c:pt idx="1">
                  <c:v>Tregs</c:v>
                </c:pt>
                <c:pt idx="2">
                  <c:v>Th1</c:v>
                </c:pt>
                <c:pt idx="3">
                  <c:v>Th2</c:v>
                </c:pt>
                <c:pt idx="4">
                  <c:v>Other T-cells</c:v>
                </c:pt>
              </c:strCache>
            </c:strRef>
          </c:cat>
          <c:val>
            <c:numRef>
              <c:f>'Main T cell types'!$N$4:$N$8</c:f>
              <c:numCache>
                <c:formatCode>General</c:formatCode>
                <c:ptCount val="5"/>
                <c:pt idx="0">
                  <c:v>12.620449678800858</c:v>
                </c:pt>
                <c:pt idx="1">
                  <c:v>4.8982999999999999</c:v>
                </c:pt>
                <c:pt idx="2">
                  <c:v>0.1739829</c:v>
                </c:pt>
                <c:pt idx="3">
                  <c:v>10.210000000000001</c:v>
                </c:pt>
                <c:pt idx="4">
                  <c:v>1.15096359743040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869-C147-A6ED-ED6DA1A5B9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ti-PD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D6A-B34F-8B98-3A9431A6EBE0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D6A-B34F-8B98-3A9431A6EBE0}"/>
              </c:ext>
            </c:extLst>
          </c:dPt>
          <c:dPt>
            <c:idx val="2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D6A-B34F-8B98-3A9431A6EBE0}"/>
              </c:ext>
            </c:extLst>
          </c:dPt>
          <c:dPt>
            <c:idx val="3"/>
            <c:bubble3D val="0"/>
            <c:spPr>
              <a:solidFill>
                <a:srgbClr val="FFA90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D6A-B34F-8B98-3A9431A6EBE0}"/>
              </c:ext>
            </c:extLst>
          </c:dPt>
          <c:dPt>
            <c:idx val="4"/>
            <c:bubble3D val="0"/>
            <c:spPr>
              <a:solidFill>
                <a:schemeClr val="accent3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D6A-B34F-8B98-3A9431A6EBE0}"/>
              </c:ext>
            </c:extLst>
          </c:dPt>
          <c:cat>
            <c:strRef>
              <c:f>'Main T cell types'!$G$4:$G$8</c:f>
              <c:strCache>
                <c:ptCount val="5"/>
                <c:pt idx="0">
                  <c:v>CTLs</c:v>
                </c:pt>
                <c:pt idx="1">
                  <c:v>Tregs</c:v>
                </c:pt>
                <c:pt idx="2">
                  <c:v>Th1</c:v>
                </c:pt>
                <c:pt idx="3">
                  <c:v>Th2</c:v>
                </c:pt>
                <c:pt idx="4">
                  <c:v>Other T-cells</c:v>
                </c:pt>
              </c:strCache>
            </c:strRef>
          </c:cat>
          <c:val>
            <c:numRef>
              <c:f>'Main T cell types'!$P$4:$P$8</c:f>
              <c:numCache>
                <c:formatCode>General</c:formatCode>
                <c:ptCount val="5"/>
                <c:pt idx="0">
                  <c:v>18.205700774990149</c:v>
                </c:pt>
                <c:pt idx="1">
                  <c:v>6.0553999999999997</c:v>
                </c:pt>
                <c:pt idx="2">
                  <c:v>1.0639695</c:v>
                </c:pt>
                <c:pt idx="3">
                  <c:v>10.9</c:v>
                </c:pt>
                <c:pt idx="4">
                  <c:v>1.12964665703402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D6A-B34F-8B98-3A9431A6EB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rgbClr val="0070C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671-154D-A93E-5F02FEA1F9CF}"/>
              </c:ext>
            </c:extLst>
          </c:dPt>
          <c:dPt>
            <c:idx val="1"/>
            <c:bubble3D val="0"/>
            <c:spPr>
              <a:solidFill>
                <a:schemeClr val="accent6">
                  <a:lumMod val="75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671-154D-A93E-5F02FEA1F9CF}"/>
              </c:ext>
            </c:extLst>
          </c:dPt>
          <c:dPt>
            <c:idx val="2"/>
            <c:bubble3D val="0"/>
            <c:spPr>
              <a:solidFill>
                <a:schemeClr val="accent4">
                  <a:lumMod val="60000"/>
                  <a:lumOff val="4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671-154D-A93E-5F02FEA1F9CF}"/>
              </c:ext>
            </c:extLst>
          </c:dPt>
          <c:dPt>
            <c:idx val="3"/>
            <c:bubble3D val="0"/>
            <c:spPr>
              <a:solidFill>
                <a:srgbClr val="FFA90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671-154D-A93E-5F02FEA1F9CF}"/>
              </c:ext>
            </c:extLst>
          </c:dPt>
          <c:dPt>
            <c:idx val="4"/>
            <c:bubble3D val="0"/>
            <c:spPr>
              <a:solidFill>
                <a:schemeClr val="accent3">
                  <a:lumMod val="20000"/>
                  <a:lumOff val="8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8671-154D-A93E-5F02FEA1F9CF}"/>
              </c:ext>
            </c:extLst>
          </c:dPt>
          <c:cat>
            <c:strRef>
              <c:f>'Main T cell types'!$G$4:$G$8</c:f>
              <c:strCache>
                <c:ptCount val="5"/>
                <c:pt idx="0">
                  <c:v>CTLs</c:v>
                </c:pt>
                <c:pt idx="1">
                  <c:v>Tregs</c:v>
                </c:pt>
                <c:pt idx="2">
                  <c:v>Th1</c:v>
                </c:pt>
                <c:pt idx="3">
                  <c:v>Th2</c:v>
                </c:pt>
                <c:pt idx="4">
                  <c:v>Other T-cells</c:v>
                </c:pt>
              </c:strCache>
            </c:strRef>
          </c:cat>
          <c:val>
            <c:numRef>
              <c:f>'Main T cell types'!$L$4:$L$8</c:f>
              <c:numCache>
                <c:formatCode>General</c:formatCode>
                <c:ptCount val="5"/>
                <c:pt idx="0">
                  <c:v>11.586161879895561</c:v>
                </c:pt>
                <c:pt idx="1">
                  <c:v>7.5717999999999996</c:v>
                </c:pt>
                <c:pt idx="2">
                  <c:v>1.3054829999999999</c:v>
                </c:pt>
                <c:pt idx="3">
                  <c:v>3.9329999999999998</c:v>
                </c:pt>
                <c:pt idx="4">
                  <c:v>3.10052219321148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8671-154D-A93E-5F02FEA1F9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F25CA3-458B-EA46-F4C7-7BFF54799AC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EFC04FB-870A-8A0C-AA15-68411C9B067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2313D0-E7B7-3A5A-1E01-3E0B3B27E8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45D64A-8CE4-15A8-F61D-665D8D0366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23A878-C979-8756-BFD4-7FE278EAA7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965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F3F431-E6BB-3AD2-5752-8327F0924C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991857-39B1-5778-C292-297BCE8FDC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DEDE6E-5655-9DCA-6AAE-75E06AE12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902644-B3B5-025D-5F67-B8F19D87C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38EA30-C764-D741-8893-25E6720AC5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955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B410CE-DC58-4881-F325-FDD7827F16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B40226-B7C3-341D-98C3-2E1089A6AE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3710B7-55B5-29DB-8C0A-17CBEBACDA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5FF171-0AE3-00D0-4BBF-3805AFBD2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56EAF5-CCAF-5C44-CEDE-1C1DA0A45F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852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C0B75-94E2-A6E7-36D9-91BBE4612A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696DEC-57CB-5EBB-64D3-3FC8FC13D0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B9D02F-DC0E-020F-5BCA-BFF392A31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009B8E-AC40-141B-A9D8-0DE87D445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8F51D5-2C47-6A5C-3EB7-EB3E4369C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526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EE429E-D5E5-702A-FDE6-F1D5E5BA83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6263FF-9F8B-B06E-9947-EA3DE996D9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F688F9-04C2-B3E5-D6F1-CEC758FFD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AB713A-59D1-97C3-17E8-1CCFC5F3D0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C6A64-5841-5339-FADB-1DB17ADF8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995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95E386-2478-CEFA-F8AD-2D4595E22A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41722C-B397-DF33-783C-FF4B4370F8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1AAD5D-0C43-C9CD-AC76-A7A5E11E53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F61599-AD62-D558-C0A5-2F8A5C5B9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63F633-39DF-13E0-73DB-2D00E0805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C94196-5FC9-F946-D7CF-41F259902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128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3C4972-0CBB-B449-24ED-5154899D8E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3D3D98-1C1E-38B4-B3B8-04ED7BEB7C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9F8D21-895F-E29B-7EE6-FCCF3FC0D6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29DC76E-BB8F-62C1-C825-2768E31C35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1B3FF1-8379-8F3E-3289-DA230FAE31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037641-9FDE-223C-DAD1-A0EAF6432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FCF978E-0CC7-43BA-7101-4B371856D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693D05-F4D8-9706-E71C-C9B83AC60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8681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346E6C-1A87-FEF4-0B62-FB438532D6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70A5FF-9904-EE9B-9267-972D8A7B1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DE5BE08-68DD-F39C-D36D-AB13004AC2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D1C5B3-7CFF-F421-756E-31F186FF18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322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67FB66-A490-CD8B-6F14-D46622EE80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344E2DA-E187-0C7C-62D2-CAD5066DAC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5F14EF-F06E-A851-0A0F-C25C368C6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1622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9502A-1DFB-2A08-6E45-1EF144E7C0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861735-90AC-25D2-F6ED-3C6D7C2E36D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4867BA-55C0-2756-4299-02DDBCB54A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C02D90-30C5-2B3C-9D18-059F9BCD0B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B083DD-4EB5-C611-6A3F-994D9459B5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4608FA-8CA1-925C-DD3B-83B54295CF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207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1B1808-CE5B-85C0-2BE6-4FEFD0F370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F439DE-FDAF-3035-0FFF-DF49855A65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997B0A-BBA1-D082-18D8-C9A81A9DCE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8A6372-A0A1-07AE-3C37-32EE4D295C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F0E077-CFA9-8359-11D4-F9EFBE84B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945C95-8725-708D-86B3-F4D2B11D6C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9021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448F722-F864-14CE-BFC2-5D78E6A125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3B100E-143E-5603-4B71-80D937A4B4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A93A9C-8AA3-F2E7-81B4-EC1E46ACA06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065924-24C2-B246-A28C-139A98806734}" type="datetimeFigureOut">
              <a:rPr lang="en-US" smtClean="0"/>
              <a:t>3/2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BE970C-C7DC-FD25-6868-839FA60254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30A58C-7D79-4AAC-EC37-4A62D803DD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E7C9C-C4B0-2D40-9D6A-0713DC9E85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586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B6DD2CC-FE2C-5D64-1A89-8B757DD77E2C}"/>
              </a:ext>
            </a:extLst>
          </p:cNvPr>
          <p:cNvSpPr txBox="1"/>
          <p:nvPr/>
        </p:nvSpPr>
        <p:spPr>
          <a:xfrm>
            <a:off x="14597" y="3390900"/>
            <a:ext cx="28844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20D2EDA5-60AB-8E6C-4555-73296945C4F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45792" y="3611350"/>
          <a:ext cx="4034365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A8929C56-1489-EA4F-13CE-3E115EA4170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71179" y="3658907"/>
          <a:ext cx="4044916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3965B631-032E-590C-696E-F63B4B792A2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609389" y="3682600"/>
          <a:ext cx="4025268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301D5403-6876-DC20-5461-390A24A46CC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914541" y="3693683"/>
          <a:ext cx="6046318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9" name="Rectangle 8">
            <a:extLst>
              <a:ext uri="{FF2B5EF4-FFF2-40B4-BE49-F238E27FC236}">
                <a16:creationId xmlns:a16="http://schemas.microsoft.com/office/drawing/2014/main" id="{A146CD70-D62C-FBFB-9EE9-0DADD22F9A48}"/>
              </a:ext>
            </a:extLst>
          </p:cNvPr>
          <p:cNvSpPr/>
          <p:nvPr/>
        </p:nvSpPr>
        <p:spPr>
          <a:xfrm>
            <a:off x="4133106" y="4941726"/>
            <a:ext cx="67358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TL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A568CCE-AA28-9FC0-99ED-797983FC3D5E}"/>
              </a:ext>
            </a:extLst>
          </p:cNvPr>
          <p:cNvSpPr/>
          <p:nvPr/>
        </p:nvSpPr>
        <p:spPr>
          <a:xfrm>
            <a:off x="6397473" y="5050887"/>
            <a:ext cx="67358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TL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76CA0A4-7B33-04F4-0739-A6758BDFD122}"/>
              </a:ext>
            </a:extLst>
          </p:cNvPr>
          <p:cNvSpPr/>
          <p:nvPr/>
        </p:nvSpPr>
        <p:spPr>
          <a:xfrm>
            <a:off x="8792320" y="4968407"/>
            <a:ext cx="67358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TL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69A4D8B2-4895-0E84-0B9A-6A5B48DB2FEB}"/>
              </a:ext>
            </a:extLst>
          </p:cNvPr>
          <p:cNvSpPr/>
          <p:nvPr/>
        </p:nvSpPr>
        <p:spPr>
          <a:xfrm>
            <a:off x="11145175" y="5036726"/>
            <a:ext cx="67358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TLs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E8F6729-293D-3729-3ABA-1C3B4A9ECE4C}"/>
              </a:ext>
            </a:extLst>
          </p:cNvPr>
          <p:cNvSpPr/>
          <p:nvPr/>
        </p:nvSpPr>
        <p:spPr>
          <a:xfrm>
            <a:off x="3479970" y="5782684"/>
            <a:ext cx="70121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7C9A6EF-9B8B-1155-B7DF-2F130B0DD7EB}"/>
              </a:ext>
            </a:extLst>
          </p:cNvPr>
          <p:cNvSpPr/>
          <p:nvPr/>
        </p:nvSpPr>
        <p:spPr>
          <a:xfrm rot="17050293">
            <a:off x="5739212" y="5831177"/>
            <a:ext cx="70121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102CD57C-D1C8-5D4E-999C-2119FD13EE89}"/>
              </a:ext>
            </a:extLst>
          </p:cNvPr>
          <p:cNvSpPr/>
          <p:nvPr/>
        </p:nvSpPr>
        <p:spPr>
          <a:xfrm>
            <a:off x="8153807" y="5848467"/>
            <a:ext cx="70121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7685F4E-EC26-947E-2D80-5ADD2DC3FD45}"/>
              </a:ext>
            </a:extLst>
          </p:cNvPr>
          <p:cNvSpPr/>
          <p:nvPr/>
        </p:nvSpPr>
        <p:spPr>
          <a:xfrm>
            <a:off x="10303379" y="5678394"/>
            <a:ext cx="70121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84FFFDC2-0236-5480-006D-C6913201A82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-379587" y="3646918"/>
          <a:ext cx="3991921" cy="2834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8" name="Rectangle 17">
            <a:extLst>
              <a:ext uri="{FF2B5EF4-FFF2-40B4-BE49-F238E27FC236}">
                <a16:creationId xmlns:a16="http://schemas.microsoft.com/office/drawing/2014/main" id="{264F65B9-3DB7-DFFA-8E9F-1DF2C187FA45}"/>
              </a:ext>
            </a:extLst>
          </p:cNvPr>
          <p:cNvSpPr/>
          <p:nvPr/>
        </p:nvSpPr>
        <p:spPr>
          <a:xfrm>
            <a:off x="1800240" y="4941726"/>
            <a:ext cx="67358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TLs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05775AE-4538-09CA-8BFB-754194FE330D}"/>
              </a:ext>
            </a:extLst>
          </p:cNvPr>
          <p:cNvSpPr/>
          <p:nvPr/>
        </p:nvSpPr>
        <p:spPr>
          <a:xfrm>
            <a:off x="1048239" y="5767737"/>
            <a:ext cx="70121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7CC5429-184B-95B0-14DB-E969585433D5}"/>
              </a:ext>
            </a:extLst>
          </p:cNvPr>
          <p:cNvSpPr/>
          <p:nvPr/>
        </p:nvSpPr>
        <p:spPr>
          <a:xfrm>
            <a:off x="720864" y="4735060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B4111B7-5144-1A32-A933-FE444F5F8F21}"/>
              </a:ext>
            </a:extLst>
          </p:cNvPr>
          <p:cNvSpPr/>
          <p:nvPr/>
        </p:nvSpPr>
        <p:spPr>
          <a:xfrm>
            <a:off x="3022341" y="4943647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69657080-679F-BED0-657F-FF41CD1FF33C}"/>
              </a:ext>
            </a:extLst>
          </p:cNvPr>
          <p:cNvSpPr/>
          <p:nvPr/>
        </p:nvSpPr>
        <p:spPr>
          <a:xfrm>
            <a:off x="5432273" y="5101732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CB07C5B4-C39C-C620-4B2C-544EB28948BF}"/>
              </a:ext>
            </a:extLst>
          </p:cNvPr>
          <p:cNvSpPr/>
          <p:nvPr/>
        </p:nvSpPr>
        <p:spPr>
          <a:xfrm>
            <a:off x="7833390" y="4928939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482F189-9168-9FE7-C4BC-3B2B225F0A9A}"/>
              </a:ext>
            </a:extLst>
          </p:cNvPr>
          <p:cNvSpPr/>
          <p:nvPr/>
        </p:nvSpPr>
        <p:spPr>
          <a:xfrm>
            <a:off x="10136424" y="4875024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832CEC45-6D73-19B5-C4A2-56D3B5007FAB}"/>
              </a:ext>
            </a:extLst>
          </p:cNvPr>
          <p:cNvSpPr/>
          <p:nvPr/>
        </p:nvSpPr>
        <p:spPr>
          <a:xfrm>
            <a:off x="575735" y="5160079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04DE75A-9591-3AEF-BF72-DD59D171C3DF}"/>
              </a:ext>
            </a:extLst>
          </p:cNvPr>
          <p:cNvSpPr/>
          <p:nvPr/>
        </p:nvSpPr>
        <p:spPr>
          <a:xfrm rot="18794702">
            <a:off x="3119578" y="5644559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FD02159-E933-0ECF-5CCF-8866F22C0EC1}"/>
              </a:ext>
            </a:extLst>
          </p:cNvPr>
          <p:cNvSpPr/>
          <p:nvPr/>
        </p:nvSpPr>
        <p:spPr>
          <a:xfrm rot="17692382">
            <a:off x="5612024" y="5875895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FECDDE8-5BDE-AB89-91F5-F9226B356AC8}"/>
              </a:ext>
            </a:extLst>
          </p:cNvPr>
          <p:cNvSpPr/>
          <p:nvPr/>
        </p:nvSpPr>
        <p:spPr>
          <a:xfrm rot="18502075">
            <a:off x="7812150" y="5712882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E023DCB9-CCCB-3FAC-458A-73B5DCD2BAAD}"/>
              </a:ext>
            </a:extLst>
          </p:cNvPr>
          <p:cNvSpPr/>
          <p:nvPr/>
        </p:nvSpPr>
        <p:spPr>
          <a:xfrm rot="19631578">
            <a:off x="9886221" y="5561353"/>
            <a:ext cx="53732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B03BB50B-0164-7E77-5503-06E660A03AF4}"/>
              </a:ext>
            </a:extLst>
          </p:cNvPr>
          <p:cNvSpPr/>
          <p:nvPr/>
        </p:nvSpPr>
        <p:spPr>
          <a:xfrm rot="2946951">
            <a:off x="775343" y="4509836"/>
            <a:ext cx="10534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ther T-cells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96B8B917-43AE-C572-0551-22BE86563910}"/>
              </a:ext>
            </a:extLst>
          </p:cNvPr>
          <p:cNvSpPr/>
          <p:nvPr/>
        </p:nvSpPr>
        <p:spPr>
          <a:xfrm rot="2475839">
            <a:off x="3090867" y="4515202"/>
            <a:ext cx="10534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ther T-cells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A274430D-1A27-31C2-F026-9A5C5662F938}"/>
              </a:ext>
            </a:extLst>
          </p:cNvPr>
          <p:cNvSpPr/>
          <p:nvPr/>
        </p:nvSpPr>
        <p:spPr>
          <a:xfrm rot="2257368">
            <a:off x="5409459" y="4602853"/>
            <a:ext cx="10534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ther T-cells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E5F8CB53-4245-ADDE-EA6C-E30529A95D44}"/>
              </a:ext>
            </a:extLst>
          </p:cNvPr>
          <p:cNvSpPr/>
          <p:nvPr/>
        </p:nvSpPr>
        <p:spPr>
          <a:xfrm rot="4643185">
            <a:off x="7992248" y="4441495"/>
            <a:ext cx="10534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ther T-cells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195A737D-6C79-C522-B7E0-84378626B717}"/>
              </a:ext>
            </a:extLst>
          </p:cNvPr>
          <p:cNvSpPr/>
          <p:nvPr/>
        </p:nvSpPr>
        <p:spPr>
          <a:xfrm rot="4887510">
            <a:off x="10339539" y="4440331"/>
            <a:ext cx="10534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ther T-cells</a:t>
            </a:r>
          </a:p>
        </p:txBody>
      </p:sp>
    </p:spTree>
    <p:extLst>
      <p:ext uri="{BB962C8B-B14F-4D97-AF65-F5344CB8AC3E}">
        <p14:creationId xmlns:p14="http://schemas.microsoft.com/office/powerpoint/2010/main" val="4061492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F7B9B2C6527ED4B872425A61FB2348D" ma:contentTypeVersion="13" ma:contentTypeDescription="Create a new document." ma:contentTypeScope="" ma:versionID="eab3e5c1ba249a1d86109643abc49beb">
  <xsd:schema xmlns:xsd="http://www.w3.org/2001/XMLSchema" xmlns:xs="http://www.w3.org/2001/XMLSchema" xmlns:p="http://schemas.microsoft.com/office/2006/metadata/properties" xmlns:ns2="a1c1925a-ca81-4b92-a099-ee59e54d030a" xmlns:ns3="86f5bbeb-a984-4fb2-bd57-831a897c44b1" targetNamespace="http://schemas.microsoft.com/office/2006/metadata/properties" ma:root="true" ma:fieldsID="4bd9371b356dbe3cb9af3a490a76fa85" ns2:_="" ns3:_="">
    <xsd:import namespace="a1c1925a-ca81-4b92-a099-ee59e54d030a"/>
    <xsd:import namespace="86f5bbeb-a984-4fb2-bd57-831a897c44b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OCR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1c1925a-ca81-4b92-a099-ee59e54d030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4b2c965b-d860-41d6-b67e-2baa6ffbc59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6f5bbeb-a984-4fb2-bd57-831a897c44b1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012befff-b5e3-44f3-a870-0e1b3c30fa1a}" ma:internalName="TaxCatchAll" ma:showField="CatchAllData" ma:web="86f5bbeb-a984-4fb2-bd57-831a897c44b1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86f5bbeb-a984-4fb2-bd57-831a897c44b1" xsi:nil="true"/>
    <lcf76f155ced4ddcb4097134ff3c332f xmlns="a1c1925a-ca81-4b92-a099-ee59e54d030a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40F9AEE9-13A7-4108-92A7-AC6E9DB565FF}"/>
</file>

<file path=customXml/itemProps2.xml><?xml version="1.0" encoding="utf-8"?>
<ds:datastoreItem xmlns:ds="http://schemas.openxmlformats.org/officeDocument/2006/customXml" ds:itemID="{0D837753-7912-4715-9D4B-7CF110D9B60D}"/>
</file>

<file path=customXml/itemProps3.xml><?xml version="1.0" encoding="utf-8"?>
<ds:datastoreItem xmlns:ds="http://schemas.openxmlformats.org/officeDocument/2006/customXml" ds:itemID="{EAF7D8AB-75C3-47E7-9641-5CC6AE80EB36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</Words>
  <Application>Microsoft Macintosh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bhani, Navid</dc:creator>
  <cp:lastModifiedBy>Sobhani, Navid</cp:lastModifiedBy>
  <cp:revision>1</cp:revision>
  <dcterms:created xsi:type="dcterms:W3CDTF">2023-03-21T20:57:16Z</dcterms:created>
  <dcterms:modified xsi:type="dcterms:W3CDTF">2023-03-21T20:57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F7B9B2C6527ED4B872425A61FB2348D</vt:lpwstr>
  </property>
</Properties>
</file>